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7" autoAdjust="0"/>
    <p:restoredTop sz="94660"/>
  </p:normalViewPr>
  <p:slideViewPr>
    <p:cSldViewPr snapToGrid="0">
      <p:cViewPr varScale="1">
        <p:scale>
          <a:sx n="96" d="100"/>
          <a:sy n="96" d="100"/>
        </p:scale>
        <p:origin x="30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415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203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10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707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983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76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63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636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950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581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39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F100B8-3946-490A-962F-42905990B47F}" type="datetimeFigureOut">
              <a:rPr lang="en-US" smtClean="0"/>
              <a:t>5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6DE4A3-902E-4990-88C6-075FE03FAE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909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40B724C0-4026-4346-B2FB-3A2A508380A2}"/>
              </a:ext>
            </a:extLst>
          </p:cNvPr>
          <p:cNvSpPr txBox="1"/>
          <p:nvPr/>
        </p:nvSpPr>
        <p:spPr>
          <a:xfrm>
            <a:off x="97430" y="1124129"/>
            <a:ext cx="29998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tromelysi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I / MMP3 - m/z 1097.54: 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74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GPGNVLAHA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84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D32B31C-AF6E-41C6-A49C-9BF627420AB6}"/>
              </a:ext>
            </a:extLst>
          </p:cNvPr>
          <p:cNvSpPr/>
          <p:nvPr/>
        </p:nvSpPr>
        <p:spPr>
          <a:xfrm>
            <a:off x="3590983" y="1124129"/>
            <a:ext cx="299523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0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ndroadherin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– m/z 1482.77: L</a:t>
            </a:r>
            <a:r>
              <a:rPr lang="en-US" sz="1000" b="1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6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PGALDDVENLAK</a:t>
            </a:r>
            <a:r>
              <a:rPr lang="en-US" sz="1000" b="1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99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87AA9C3-70C2-483A-9187-94788C0F76B1}"/>
              </a:ext>
            </a:extLst>
          </p:cNvPr>
          <p:cNvSpPr/>
          <p:nvPr/>
        </p:nvSpPr>
        <p:spPr>
          <a:xfrm>
            <a:off x="97430" y="2686961"/>
            <a:ext cx="341607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) Pigment epithelium-derived factor / SERPINEF1 – m/z 1233.59:  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b="1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FGYDLYR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7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59D7E07-81C7-4A4A-AE70-16E8734B22B5}"/>
              </a:ext>
            </a:extLst>
          </p:cNvPr>
          <p:cNvSpPr/>
          <p:nvPr/>
        </p:nvSpPr>
        <p:spPr>
          <a:xfrm>
            <a:off x="3590983" y="2686961"/>
            <a:ext cx="184108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lusterin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– m/z 1468.66: I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86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DELFQDRF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9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C7EECA5-D6F5-75B7-0E6E-60C35145ADA2}"/>
              </a:ext>
            </a:extLst>
          </p:cNvPr>
          <p:cNvSpPr txBox="1"/>
          <p:nvPr/>
        </p:nvSpPr>
        <p:spPr>
          <a:xfrm>
            <a:off x="224721" y="4652459"/>
            <a:ext cx="648031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0 – Lower abundant detected non-collagenous proteins. </a:t>
            </a:r>
            <a:r>
              <a:rPr lang="en-US" sz="1400" kern="0" dirty="0">
                <a:solidFill>
                  <a:srgbClr val="2121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400" kern="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e enzymatic collagenase digestion method 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enriches </a:t>
            </a:r>
            <a:r>
              <a:rPr lang="en-US" sz="1400" dirty="0">
                <a:latin typeface="Arial" panose="020B0604020202020204" pitchFamily="34" charset="0"/>
                <a:ea typeface="Aptos" panose="020B0004020202020204" pitchFamily="34" charset="0"/>
              </a:rPr>
              <a:t>for 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ECM proteins which include highly abundant collagens but also for peptides of other less abundant ECM and non-ECM proteins including A)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tromelysi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 / MMP3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, B) </a:t>
            </a:r>
            <a:r>
              <a:rPr lang="en-US" sz="140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Chondrohaderin</a:t>
            </a:r>
            <a:r>
              <a:rPr lang="en-US" sz="14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C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igment epithelium-derived factor / SERPINEF1  and D)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lusteri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many others. Many of these non-collagenous proteins did not show regulation by disease state in this study.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EF5DC47-B689-B5A9-CDC9-D3DB3C64E649}"/>
              </a:ext>
            </a:extLst>
          </p:cNvPr>
          <p:cNvGrpSpPr/>
          <p:nvPr/>
        </p:nvGrpSpPr>
        <p:grpSpPr>
          <a:xfrm>
            <a:off x="241406" y="1469831"/>
            <a:ext cx="3171126" cy="1073580"/>
            <a:chOff x="241406" y="1469831"/>
            <a:chExt cx="3171126" cy="107358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B04D1AE-7158-407D-B377-AACF8F9F4B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9768"/>
            <a:stretch/>
          </p:blipFill>
          <p:spPr>
            <a:xfrm>
              <a:off x="241406" y="1469831"/>
              <a:ext cx="3129919" cy="1073580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208764DC-A430-351A-B525-C2D157498DFF}"/>
                </a:ext>
              </a:extLst>
            </p:cNvPr>
            <p:cNvSpPr/>
            <p:nvPr/>
          </p:nvSpPr>
          <p:spPr>
            <a:xfrm>
              <a:off x="3143261" y="2247452"/>
              <a:ext cx="269271" cy="953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2DD46D71-8AEE-D4F1-6DC7-6790209FE8F6}"/>
                </a:ext>
              </a:extLst>
            </p:cNvPr>
            <p:cNvSpPr/>
            <p:nvPr/>
          </p:nvSpPr>
          <p:spPr>
            <a:xfrm>
              <a:off x="1635155" y="2248387"/>
              <a:ext cx="919075" cy="1056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E68C95D-D392-A094-15CD-D97DA636FB1F}"/>
                </a:ext>
              </a:extLst>
            </p:cNvPr>
            <p:cNvSpPr txBox="1"/>
            <p:nvPr/>
          </p:nvSpPr>
          <p:spPr>
            <a:xfrm>
              <a:off x="1583732" y="2219862"/>
              <a:ext cx="10883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/z 1097.54 ± 15 ppm</a:t>
              </a:r>
              <a:endParaRPr lang="en-US" sz="600" b="1" dirty="0"/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DF6AB78F-D7C6-0139-7E56-EF0F2084B5EF}"/>
              </a:ext>
            </a:extLst>
          </p:cNvPr>
          <p:cNvGrpSpPr/>
          <p:nvPr/>
        </p:nvGrpSpPr>
        <p:grpSpPr>
          <a:xfrm>
            <a:off x="3717435" y="1540157"/>
            <a:ext cx="3013428" cy="1011382"/>
            <a:chOff x="3717435" y="1532029"/>
            <a:chExt cx="3013428" cy="1011382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00840BD-D1C6-473C-BBE0-C03006E580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40387"/>
            <a:stretch/>
          </p:blipFill>
          <p:spPr>
            <a:xfrm>
              <a:off x="3717435" y="1532029"/>
              <a:ext cx="2979200" cy="1011382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BF4D56E-054F-A3F9-9599-3917EF179483}"/>
                </a:ext>
              </a:extLst>
            </p:cNvPr>
            <p:cNvSpPr/>
            <p:nvPr/>
          </p:nvSpPr>
          <p:spPr>
            <a:xfrm>
              <a:off x="6461592" y="2285932"/>
              <a:ext cx="269271" cy="953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EACB0556-D883-DBB6-4AE3-FC177D855B0C}"/>
                </a:ext>
              </a:extLst>
            </p:cNvPr>
            <p:cNvSpPr/>
            <p:nvPr/>
          </p:nvSpPr>
          <p:spPr>
            <a:xfrm>
              <a:off x="5027386" y="2252701"/>
              <a:ext cx="919075" cy="1056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47C9864-D856-C755-F81E-7715A1F84DEC}"/>
                </a:ext>
              </a:extLst>
            </p:cNvPr>
            <p:cNvSpPr txBox="1"/>
            <p:nvPr/>
          </p:nvSpPr>
          <p:spPr>
            <a:xfrm>
              <a:off x="4940359" y="2227666"/>
              <a:ext cx="10883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/z 1482.77 ± 15 ppm</a:t>
              </a:r>
              <a:endParaRPr lang="en-US" sz="600" b="1" dirty="0"/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C1C44A82-BF85-51A7-177A-0EBBBF64240C}"/>
              </a:ext>
            </a:extLst>
          </p:cNvPr>
          <p:cNvGrpSpPr/>
          <p:nvPr/>
        </p:nvGrpSpPr>
        <p:grpSpPr>
          <a:xfrm>
            <a:off x="241406" y="3219917"/>
            <a:ext cx="3173932" cy="1073580"/>
            <a:chOff x="241406" y="3219917"/>
            <a:chExt cx="3173932" cy="1073580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10392E5-C659-41F3-ADE6-71B7662A99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39768"/>
            <a:stretch/>
          </p:blipFill>
          <p:spPr>
            <a:xfrm>
              <a:off x="241406" y="3219917"/>
              <a:ext cx="3129919" cy="1073580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5EF8A2D8-D2E9-E480-15DC-CD53471B9D7F}"/>
                </a:ext>
              </a:extLst>
            </p:cNvPr>
            <p:cNvSpPr/>
            <p:nvPr/>
          </p:nvSpPr>
          <p:spPr>
            <a:xfrm>
              <a:off x="3146067" y="3989301"/>
              <a:ext cx="269271" cy="953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F47B7970-8DCE-5B28-0AA8-038D792168A4}"/>
                </a:ext>
              </a:extLst>
            </p:cNvPr>
            <p:cNvSpPr/>
            <p:nvPr/>
          </p:nvSpPr>
          <p:spPr>
            <a:xfrm>
              <a:off x="1631414" y="3994909"/>
              <a:ext cx="919075" cy="1056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17CF16B-996A-F8AC-496E-12110C3F969B}"/>
                </a:ext>
              </a:extLst>
            </p:cNvPr>
            <p:cNvSpPr txBox="1"/>
            <p:nvPr/>
          </p:nvSpPr>
          <p:spPr>
            <a:xfrm>
              <a:off x="1579057" y="3965450"/>
              <a:ext cx="10883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/z 1233.59 ± 15 ppm</a:t>
              </a:r>
              <a:endParaRPr lang="en-US" sz="600" b="1" dirty="0"/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B295878C-CA29-D190-B640-A5E6E272CD15}"/>
              </a:ext>
            </a:extLst>
          </p:cNvPr>
          <p:cNvGrpSpPr/>
          <p:nvPr/>
        </p:nvGrpSpPr>
        <p:grpSpPr>
          <a:xfrm>
            <a:off x="3717435" y="3219917"/>
            <a:ext cx="3034808" cy="1073580"/>
            <a:chOff x="3717435" y="3219917"/>
            <a:chExt cx="3034808" cy="1073580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E50219B-8523-4AE7-86DC-5C50CC07A9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37625"/>
            <a:stretch/>
          </p:blipFill>
          <p:spPr>
            <a:xfrm>
              <a:off x="3717435" y="3219917"/>
              <a:ext cx="3022362" cy="1073580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F988A89B-04C4-8F65-2240-E7EF8C7BA886}"/>
                </a:ext>
              </a:extLst>
            </p:cNvPr>
            <p:cNvSpPr/>
            <p:nvPr/>
          </p:nvSpPr>
          <p:spPr>
            <a:xfrm>
              <a:off x="6482972" y="4002607"/>
              <a:ext cx="269271" cy="953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402816E3-BA56-2356-CD4D-D4D066194D38}"/>
                </a:ext>
              </a:extLst>
            </p:cNvPr>
            <p:cNvSpPr/>
            <p:nvPr/>
          </p:nvSpPr>
          <p:spPr>
            <a:xfrm>
              <a:off x="5030964" y="4009151"/>
              <a:ext cx="919075" cy="1056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6691CD0-1085-887A-5E3E-4562E0E4EADE}"/>
                </a:ext>
              </a:extLst>
            </p:cNvPr>
            <p:cNvSpPr txBox="1"/>
            <p:nvPr/>
          </p:nvSpPr>
          <p:spPr>
            <a:xfrm>
              <a:off x="4985151" y="3969407"/>
              <a:ext cx="10883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/z 146.66 ± 15 ppm</a:t>
              </a:r>
              <a:endParaRPr lang="en-US" sz="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79040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4</TotalTime>
  <Words>153</Words>
  <Application>Microsoft Macintosh PowerPoint</Application>
  <PresentationFormat>Letter Paper (8.5x11 in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maging Mass Spec Computer</dc:creator>
  <cp:lastModifiedBy>Charlie Schurman</cp:lastModifiedBy>
  <cp:revision>7</cp:revision>
  <dcterms:created xsi:type="dcterms:W3CDTF">2025-05-28T21:11:46Z</dcterms:created>
  <dcterms:modified xsi:type="dcterms:W3CDTF">2025-05-28T22:57:17Z</dcterms:modified>
</cp:coreProperties>
</file>